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7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130928-030B-41F3-A046-D9C0AF51A9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DE5C0C5-90C1-4924-A43D-C0D935365A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5C612-04C3-442B-8958-16906D835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C10D07-0DD0-4102-A632-643CD9205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9B4647-D99B-4E89-B6A3-45F25BABC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691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3804FA-CF2A-4240-8664-071CD9208C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4761F1-B8E7-40EF-ABA7-10DB40A64B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7C7D3-2918-4A1C-9502-9AB49A7F03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DAEAC7-16B3-41F3-A95A-1EC269AC2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A12C7-0A85-477A-A17E-E2984B0CF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360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3912BF-F29D-451A-8AF5-78148FA61C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231FE3-E76A-490D-B171-BF32387EA9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5E52C-D99F-4CDF-9791-F45ED25CC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A7F8-5ADD-48CC-8985-A9BC45DE1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C29D50-565A-418C-9D87-D0F719848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183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51F42A-D2D2-4254-A20F-34EA9EEBAB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41ED68-738E-4ACB-877B-04A3605E90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57078-4D2A-4BE9-8527-DCE26114F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A0CDF-3AFF-49E5-83B2-F73C271F7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50BF1C-2246-4D86-B183-A2C84054B2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595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99465-48CD-4803-95C5-1E7585B946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35345F-6FC8-4974-A77B-AD6DF07189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6B089B-B0A2-4726-9D4F-E03FEE9EF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729C4-8730-4EC5-9097-8DFE701FB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ED2E29-3F31-4D80-B22E-41DA559ED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93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2D2218-E6BF-4DC2-9A6F-530D6A959A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8FCDF4-160E-47AA-878B-B550D111C63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695813-8197-4559-84E5-C52CB4E2C4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454ADD-E8C3-480C-8CE5-65D0B5DF2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DC9A30-0029-423A-862F-2CF0CB9F60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4FF2EE-80A8-4668-9692-A54F1F820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522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90D4AC-9555-46CA-AADA-A3C1DA677A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0B3A60-FF43-4921-B0F3-212AEF9DF3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974B6B-411A-43A1-A675-4B46347A0C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AB4E1EA-0A17-4666-8303-D2E5E16097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E258F3-9B69-47DB-9551-52143268E4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22E692-B52F-4475-BC23-ACED9F279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34ABE7-7CB7-4834-B8F1-A9444FF07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DE9ADDE-E6DA-4797-A3F1-43F3155C5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54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23832-CA00-45D7-8C65-1059F0D73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44C87E-3020-457C-9F7C-39599731C8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108A930-07E1-48C1-97CC-1EF06678E3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B0FA1AD-7D1F-4AE4-9E7E-CF9F6E951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55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2178006-F043-4E48-9CAF-C33150DA1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DBC3B3-255B-4CE7-9D27-276058C153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600A7D5-1EE8-4824-B9E8-2CA148ED5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77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FEFC48-20B9-4D53-84B1-AA1F3B62B2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542568-9970-428E-94D5-4C8ACBF495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1EA1DE-3E86-4DEE-BC1E-0E1050EF4F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1A786F-8941-45E0-AA0E-76E904808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452200-838A-403A-9C33-CE3F5E5BA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975A83-C50D-4DE9-B0D3-215FAFAD3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54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71D1B4-F990-4F62-A393-C1F0F698F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165BC39-1A67-4964-B96A-299F73DEF25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9CAF62-9C83-427A-9568-39B29CBF28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454BAE-37FC-4D7B-B4D2-CEE5722AA6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24475E-4DF9-41B7-B95F-C56AA252E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1A931F-D3FE-408C-B4E2-32EBD4F07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748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F941AAF-0134-4472-BDFA-8B9C03AAE8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0651AC-FD51-426D-A0B5-23C7A490AE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574DB8-EA22-4F38-B506-60860452FE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CA761-9E7A-4215-95E6-E248DF54AB7D}" type="datetimeFigureOut">
              <a:rPr lang="en-US" smtClean="0"/>
              <a:t>7/18/20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F4CD81-39DB-47A3-B8FB-A964EE3D2C4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3909E0-4713-463E-B7E6-BA95D4A0BB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FCA0B-1316-4DFD-BF92-BB3860BF69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859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1676401" y="1600196"/>
          <a:ext cx="8610599" cy="3541740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10668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227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202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08638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1957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11866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38446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arameters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Mean 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STD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difference with Young Untreated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ean difference with Young Untreated</a:t>
                      </a:r>
                      <a:r>
                        <a:rPr lang="en-US" sz="16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%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1" u="none" strike="noStrike" dirty="0">
                          <a:effectLst/>
                        </a:rPr>
                        <a:t>Presence in plausible solutions (% )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R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>
                          <a:effectLst/>
                        </a:rPr>
                        <a:t>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>
                          <a:effectLst/>
                        </a:rPr>
                        <a:t>33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MC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PR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VGCC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x10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6x10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2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6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O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  <a:endParaRPr lang="en-US" sz="1400" b="0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I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0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1" i="0" u="none" strike="noStrike" baseline="-2500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  <a:endParaRPr lang="en-US" sz="1400" b="1" i="0" u="none" strike="noStrike" baseline="-25000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.9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5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u="none" strike="noStrike" dirty="0">
                          <a:effectLst/>
                        </a:rPr>
                        <a:t>100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341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-</a:t>
                      </a:r>
                      <a:r>
                        <a:rPr lang="en-US" sz="14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u="none" strike="noStrike" dirty="0">
                          <a:effectLst/>
                        </a:rPr>
                        <a:t>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676400" y="1207532"/>
            <a:ext cx="2819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Aged Unstressed Worm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52600" y="152400"/>
            <a:ext cx="243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3 Table</a:t>
            </a:r>
          </a:p>
        </p:txBody>
      </p:sp>
    </p:spTree>
    <p:extLst>
      <p:ext uri="{BB962C8B-B14F-4D97-AF65-F5344CB8AC3E}">
        <p14:creationId xmlns:p14="http://schemas.microsoft.com/office/powerpoint/2010/main" val="3372894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Widescreen</PresentationFormat>
  <Paragraphs>7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itsaG</dc:creator>
  <cp:lastModifiedBy>LenitsaG</cp:lastModifiedBy>
  <cp:revision>2</cp:revision>
  <dcterms:created xsi:type="dcterms:W3CDTF">2018-07-16T16:32:46Z</dcterms:created>
  <dcterms:modified xsi:type="dcterms:W3CDTF">2018-07-18T16:52:56Z</dcterms:modified>
</cp:coreProperties>
</file>